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0" d="100"/>
          <a:sy n="100" d="100"/>
        </p:scale>
        <p:origin x="84" y="2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171809-84EB-728D-6053-3FA42E4937E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22E8F46-367E-25C2-9CD1-00B1554C42D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1AD684-4078-EDDA-0F9B-6994637F7C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C886FC-CD3C-41E8-D7BF-CF4142EBD7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4C5949-5EAD-0DB3-DD1E-5478E7D37D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99275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5AABC1-CD5E-5EFF-89D4-D6A325D3FA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0F2041E-2EFA-6D80-3C3A-A4B7E97BB1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DDB4F4-0251-504B-844F-7CE3F692E4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D5FEC3-CB81-B83D-F168-BFAE006E7D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A68F54-080F-8B7E-772B-ED00526573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41385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3C94210-6013-D5CD-DAC2-5098BCD6A8A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1DD018F-40B1-F496-8F28-F9917E9B64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F4ECFF-4B4E-6B8D-6694-4C054DA2E5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788D37-7CB7-7DF4-8302-6B344BE8F2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D12FAA-824C-BF39-6106-EF191B5300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00810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BBA225-1AA9-4B2E-698A-07F98457B9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D560AC9-F28E-0B9B-ABE1-3DEF3BB7ECD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A9E263-F052-7FDA-CF76-08E3EBAE9C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434D50-6756-5A7D-3BC7-284AD18005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11B3E6-64C5-021B-5971-3E3EABCFF8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89248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DA577B-F353-3395-C642-23A37E58FE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EEA07F5-EAE2-C8D3-A971-43EF3E842D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22B12A-DC6D-1FD9-B2D2-862BD2EC58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CD478E-AB42-5C55-06BC-6A3FCC22B8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FB234F-EE17-E117-0660-AD3A984268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16530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F54979-A720-F51B-11A0-0956DEADE1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E2E23F-4040-DE56-C8B2-406952840C5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B5F3886-A9C3-942A-F942-48F28ABE2B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23AA20B-3582-F132-1682-EFCE77F952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8B3E350-F99D-3C60-ACB6-5A5D50DD1A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72A48B3-E627-52AC-C493-E9C2465A2C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62406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188257-498A-A061-23D8-7AB7DEF930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68676AC-D607-CB84-1397-E2753F87C3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F20CC96-059D-7937-0BDC-E10884A73F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8AB2BD1-941B-A974-C453-1A9B0A7A125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E964FB9-7E82-166B-8E8F-92B34538A85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4B5B1E9-25BC-A446-B195-3CF9944400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6D8308F-006C-5C1A-D2D7-B7B9545C52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89122EC-0F98-9842-AFCD-A1D61F5982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25754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2EDE35-960C-5D70-0975-D838E76595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4F01722-2857-98DF-8EC6-E1C6C171CE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CF152B0-298B-4628-75E0-BE0FFF4191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FC6B53F-37F1-50B0-41E9-4CE68CB9FF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28636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03A9F24-CD29-9F21-C118-2E9838586B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CB858D9-2463-D8BC-D20B-DBA0340D3F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90FA327-EC93-C4AC-AD50-994B9E0A0C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6428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FCB03F-9847-C305-79C1-1002A472E4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AB7C495-60EC-1D44-A86D-63F016809FE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C784E4C-DE5B-1E82-7EAC-B5A8BC10404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E859101-E9AE-1526-144E-60EF9E7E8E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512E089-DB36-5F97-9D05-91B1EBB223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2E68142-85B6-F708-E1F5-482AFDF2F5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84236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AE85FD-0477-349D-C459-8C2B98435F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3F4FC84-ECF1-1506-AC52-FD47F2EA653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7D58F79-D79B-205A-F000-98CCE3E9825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CABFFA4-0C26-DEB3-C56B-EEC956A190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9661803-1EE9-B997-2AEA-9E814345E4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29D3228-F668-D74B-4C5F-156CFDD551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42163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F6D8A09-E747-828F-A10B-F52707DC89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FF18A04-B462-A53E-3640-3628B2E8ED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682162-C704-7497-9487-92C16817281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2369F4-0CD6-C663-BBF0-7B94690E7DB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7AA8E1-1188-7B45-C931-2918D0AF69F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73510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>
            <a:extLst>
              <a:ext uri="{FF2B5EF4-FFF2-40B4-BE49-F238E27FC236}">
                <a16:creationId xmlns:a16="http://schemas.microsoft.com/office/drawing/2014/main" id="{5BF9C954-8F8D-8AB7-3036-276E1DA85DD9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b="16901"/>
          <a:stretch/>
        </p:blipFill>
        <p:spPr>
          <a:xfrm>
            <a:off x="4797917" y="1747849"/>
            <a:ext cx="1537288" cy="154048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F1B1EAEA-1C7A-CF2C-EE78-B202C224B713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b="18850"/>
          <a:stretch/>
        </p:blipFill>
        <p:spPr>
          <a:xfrm>
            <a:off x="6381406" y="1764587"/>
            <a:ext cx="1567161" cy="154048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118B1175-F38B-E2AF-24D3-AF7D4E967DC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19855" y="57644"/>
            <a:ext cx="1586011" cy="154048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8BA3BFEF-237A-CD7E-EDDA-C6BC5540910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443400" y="57644"/>
            <a:ext cx="1574982" cy="1576128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B76751F0-123D-8421-8C07-D32047F712FA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b="16289"/>
          <a:stretch/>
        </p:blipFill>
        <p:spPr>
          <a:xfrm>
            <a:off x="8136600" y="1751189"/>
            <a:ext cx="1547349" cy="154048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108DEB5B-15D2-D901-4FBB-0DF51ED05360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b="18413"/>
          <a:stretch/>
        </p:blipFill>
        <p:spPr>
          <a:xfrm>
            <a:off x="9814007" y="1770979"/>
            <a:ext cx="1557130" cy="1482436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1D5B4749-1ADA-DA21-FE1A-A8978E42090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092722" y="70887"/>
            <a:ext cx="1598102" cy="1540480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10CF82F6-686C-D547-7FDD-7F1303DA6BD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9851430" y="85894"/>
            <a:ext cx="1566965" cy="1510465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71666C7E-B48A-03DD-00EA-25340FB70922}"/>
              </a:ext>
            </a:extLst>
          </p:cNvPr>
          <p:cNvPicPr>
            <a:picLocks noChangeAspect="1"/>
          </p:cNvPicPr>
          <p:nvPr/>
        </p:nvPicPr>
        <p:blipFill>
          <a:blip r:embed="rId10"/>
          <a:srcRect b="17704"/>
          <a:stretch/>
        </p:blipFill>
        <p:spPr>
          <a:xfrm>
            <a:off x="4806157" y="5113052"/>
            <a:ext cx="1579240" cy="1620654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77C98CED-EE6A-02DA-F690-8091657FF0C0}"/>
              </a:ext>
            </a:extLst>
          </p:cNvPr>
          <p:cNvPicPr>
            <a:picLocks noChangeAspect="1"/>
          </p:cNvPicPr>
          <p:nvPr/>
        </p:nvPicPr>
        <p:blipFill>
          <a:blip r:embed="rId11"/>
          <a:srcRect b="18893"/>
          <a:stretch/>
        </p:blipFill>
        <p:spPr>
          <a:xfrm>
            <a:off x="6380157" y="5157578"/>
            <a:ext cx="1609031" cy="1540480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3FB828F9-E7CD-7B7C-3B96-932DA4EE235E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787643" y="3442227"/>
            <a:ext cx="1569405" cy="1540480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C2520982-B900-D57A-AFA8-EF47541F9AF1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6412447" y="3453403"/>
            <a:ext cx="1557773" cy="1540480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C900B861-3109-0428-E968-B8CB898A5250}"/>
              </a:ext>
            </a:extLst>
          </p:cNvPr>
          <p:cNvPicPr>
            <a:picLocks noChangeAspect="1"/>
          </p:cNvPicPr>
          <p:nvPr/>
        </p:nvPicPr>
        <p:blipFill>
          <a:blip r:embed="rId14"/>
          <a:srcRect b="17103"/>
          <a:stretch/>
        </p:blipFill>
        <p:spPr>
          <a:xfrm>
            <a:off x="8136736" y="5095120"/>
            <a:ext cx="1598102" cy="1620654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E3124091-60E8-82D7-6996-6319C3331CF1}"/>
              </a:ext>
            </a:extLst>
          </p:cNvPr>
          <p:cNvPicPr>
            <a:picLocks noChangeAspect="1"/>
          </p:cNvPicPr>
          <p:nvPr/>
        </p:nvPicPr>
        <p:blipFill>
          <a:blip r:embed="rId15"/>
          <a:srcRect b="19408"/>
          <a:stretch/>
        </p:blipFill>
        <p:spPr>
          <a:xfrm>
            <a:off x="9781056" y="5095120"/>
            <a:ext cx="1598102" cy="1540480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6C86D76E-8131-DE44-C5AD-B62F51A743DA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9734838" y="3472242"/>
            <a:ext cx="1644320" cy="1510465"/>
          </a:xfrm>
          <a:prstGeom prst="rect">
            <a:avLst/>
          </a:prstGeom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E02F717F-FB1B-4A7F-521F-A88C1FFAEE67}"/>
              </a:ext>
            </a:extLst>
          </p:cNvPr>
          <p:cNvSpPr txBox="1"/>
          <p:nvPr/>
        </p:nvSpPr>
        <p:spPr>
          <a:xfrm>
            <a:off x="5432115" y="6615896"/>
            <a:ext cx="5338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RSL3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C1D0A73A-01D6-5045-56A4-C745F3543B72}"/>
              </a:ext>
            </a:extLst>
          </p:cNvPr>
          <p:cNvSpPr txBox="1"/>
          <p:nvPr/>
        </p:nvSpPr>
        <p:spPr>
          <a:xfrm>
            <a:off x="6782792" y="6627168"/>
            <a:ext cx="8625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Fer-1+RSL3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CE661EDB-6BBD-A074-CBD8-05E7D0BEA590}"/>
              </a:ext>
            </a:extLst>
          </p:cNvPr>
          <p:cNvSpPr txBox="1"/>
          <p:nvPr/>
        </p:nvSpPr>
        <p:spPr>
          <a:xfrm>
            <a:off x="7036340" y="4917869"/>
            <a:ext cx="47150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Fer-1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2CC6A554-7EA3-D819-0BE3-FCD337443C2E}"/>
              </a:ext>
            </a:extLst>
          </p:cNvPr>
          <p:cNvSpPr txBox="1"/>
          <p:nvPr/>
        </p:nvSpPr>
        <p:spPr>
          <a:xfrm>
            <a:off x="5430510" y="4917869"/>
            <a:ext cx="5305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383A241C-1DC7-8A1B-D20C-D7501AC7D51C}"/>
              </a:ext>
            </a:extLst>
          </p:cNvPr>
          <p:cNvSpPr txBox="1"/>
          <p:nvPr/>
        </p:nvSpPr>
        <p:spPr>
          <a:xfrm>
            <a:off x="4025495" y="1536339"/>
            <a:ext cx="85496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4C78AC20-A116-6568-57DC-9BBEFA1E139A}"/>
              </a:ext>
            </a:extLst>
          </p:cNvPr>
          <p:cNvSpPr txBox="1"/>
          <p:nvPr/>
        </p:nvSpPr>
        <p:spPr>
          <a:xfrm>
            <a:off x="8860985" y="6603105"/>
            <a:ext cx="5338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RSL3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CB64EBA2-11F1-2A51-4337-99956AA59710}"/>
              </a:ext>
            </a:extLst>
          </p:cNvPr>
          <p:cNvSpPr txBox="1"/>
          <p:nvPr/>
        </p:nvSpPr>
        <p:spPr>
          <a:xfrm>
            <a:off x="10238336" y="6578607"/>
            <a:ext cx="8625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Fer-1+RSL3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252137C8-B930-6291-7CD4-CC005AB44B84}"/>
              </a:ext>
            </a:extLst>
          </p:cNvPr>
          <p:cNvSpPr txBox="1"/>
          <p:nvPr/>
        </p:nvSpPr>
        <p:spPr>
          <a:xfrm>
            <a:off x="10434704" y="4928195"/>
            <a:ext cx="47150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Fer-1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895368A0-2989-DAF5-65D9-5B2EAED25A2A}"/>
              </a:ext>
            </a:extLst>
          </p:cNvPr>
          <p:cNvSpPr txBox="1"/>
          <p:nvPr/>
        </p:nvSpPr>
        <p:spPr>
          <a:xfrm>
            <a:off x="8752901" y="4928195"/>
            <a:ext cx="5305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BF0766DD-7085-6824-7F84-F722AFAD78DC}"/>
              </a:ext>
            </a:extLst>
          </p:cNvPr>
          <p:cNvSpPr txBox="1"/>
          <p:nvPr/>
        </p:nvSpPr>
        <p:spPr>
          <a:xfrm>
            <a:off x="5424726" y="3172787"/>
            <a:ext cx="5338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RSL3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79860998-9E34-0DF3-73AA-81E4B76F69C4}"/>
              </a:ext>
            </a:extLst>
          </p:cNvPr>
          <p:cNvSpPr txBox="1"/>
          <p:nvPr/>
        </p:nvSpPr>
        <p:spPr>
          <a:xfrm>
            <a:off x="6822093" y="3200920"/>
            <a:ext cx="8625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Fer-1+RSL3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A0808133-A08E-D1BC-39ED-18CD9A46E8DA}"/>
              </a:ext>
            </a:extLst>
          </p:cNvPr>
          <p:cNvSpPr txBox="1"/>
          <p:nvPr/>
        </p:nvSpPr>
        <p:spPr>
          <a:xfrm>
            <a:off x="7085524" y="1565705"/>
            <a:ext cx="47150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Fer-1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B748982C-88A5-A6C4-C984-A7C1CD373430}"/>
              </a:ext>
            </a:extLst>
          </p:cNvPr>
          <p:cNvSpPr txBox="1"/>
          <p:nvPr/>
        </p:nvSpPr>
        <p:spPr>
          <a:xfrm>
            <a:off x="5455432" y="1565705"/>
            <a:ext cx="5305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A2660789-EC59-7106-870B-34399FF8D66F}"/>
              </a:ext>
            </a:extLst>
          </p:cNvPr>
          <p:cNvSpPr txBox="1"/>
          <p:nvPr/>
        </p:nvSpPr>
        <p:spPr>
          <a:xfrm>
            <a:off x="8800475" y="3168791"/>
            <a:ext cx="5338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RSL3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26AC54F8-E810-DC75-B310-C9F3B6624B34}"/>
              </a:ext>
            </a:extLst>
          </p:cNvPr>
          <p:cNvSpPr txBox="1"/>
          <p:nvPr/>
        </p:nvSpPr>
        <p:spPr>
          <a:xfrm>
            <a:off x="10258921" y="3165229"/>
            <a:ext cx="8625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Fer-1+RSL3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78B2D114-592F-53EC-BB68-418737DB78F0}"/>
              </a:ext>
            </a:extLst>
          </p:cNvPr>
          <p:cNvSpPr txBox="1"/>
          <p:nvPr/>
        </p:nvSpPr>
        <p:spPr>
          <a:xfrm>
            <a:off x="10433856" y="1566630"/>
            <a:ext cx="47150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Fer-1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BF5B1A13-8160-5BC5-6E28-D1C77B035CB1}"/>
              </a:ext>
            </a:extLst>
          </p:cNvPr>
          <p:cNvSpPr txBox="1"/>
          <p:nvPr/>
        </p:nvSpPr>
        <p:spPr>
          <a:xfrm>
            <a:off x="8803764" y="1566630"/>
            <a:ext cx="5305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3F0D2C01-4125-98A1-41B3-9718E75F1A12}"/>
              </a:ext>
            </a:extLst>
          </p:cNvPr>
          <p:cNvSpPr txBox="1"/>
          <p:nvPr/>
        </p:nvSpPr>
        <p:spPr>
          <a:xfrm>
            <a:off x="4080926" y="4870757"/>
            <a:ext cx="85496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N-term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805445C8-4A55-536D-921A-BAC6F7614109}"/>
              </a:ext>
            </a:extLst>
          </p:cNvPr>
          <p:cNvSpPr txBox="1"/>
          <p:nvPr/>
        </p:nvSpPr>
        <p:spPr>
          <a:xfrm>
            <a:off x="11464244" y="4879812"/>
            <a:ext cx="85496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C-term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0C57B3B6-478A-C465-F3D5-DBC3D6DE35FB}"/>
              </a:ext>
            </a:extLst>
          </p:cNvPr>
          <p:cNvSpPr txBox="1"/>
          <p:nvPr/>
        </p:nvSpPr>
        <p:spPr>
          <a:xfrm>
            <a:off x="11417585" y="1595194"/>
            <a:ext cx="85496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Full length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C4CF2985-642A-A854-43E7-794B50417BFB}"/>
              </a:ext>
            </a:extLst>
          </p:cNvPr>
          <p:cNvSpPr txBox="1"/>
          <p:nvPr/>
        </p:nvSpPr>
        <p:spPr>
          <a:xfrm>
            <a:off x="4659381" y="3457622"/>
            <a:ext cx="3375104" cy="334980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E77EAE68-C43B-F160-F65B-C8AF4CF37BBA}"/>
              </a:ext>
            </a:extLst>
          </p:cNvPr>
          <p:cNvSpPr txBox="1"/>
          <p:nvPr/>
        </p:nvSpPr>
        <p:spPr>
          <a:xfrm>
            <a:off x="8064830" y="49645"/>
            <a:ext cx="3375104" cy="334980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7651FF4D-7896-383C-1BD0-30199D33EFFC}"/>
              </a:ext>
            </a:extLst>
          </p:cNvPr>
          <p:cNvSpPr txBox="1"/>
          <p:nvPr/>
        </p:nvSpPr>
        <p:spPr>
          <a:xfrm>
            <a:off x="8090821" y="3446094"/>
            <a:ext cx="3375104" cy="334980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C703DE8-E742-1CD7-84C0-BDED893C4085}"/>
              </a:ext>
            </a:extLst>
          </p:cNvPr>
          <p:cNvSpPr txBox="1"/>
          <p:nvPr/>
        </p:nvSpPr>
        <p:spPr>
          <a:xfrm>
            <a:off x="4656060" y="41942"/>
            <a:ext cx="3375104" cy="334980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3B8C6EF7-AFAB-081A-A8A4-6573C0A98B90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8181766" y="3462205"/>
            <a:ext cx="1553072" cy="1500524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93C42A67-B838-CCFF-FA56-54C08E52D583}"/>
              </a:ext>
            </a:extLst>
          </p:cNvPr>
          <p:cNvPicPr>
            <a:picLocks noChangeAspect="1"/>
          </p:cNvPicPr>
          <p:nvPr/>
        </p:nvPicPr>
        <p:blipFill>
          <a:blip r:embed="rId18"/>
          <a:srcRect b="17275"/>
          <a:stretch/>
        </p:blipFill>
        <p:spPr>
          <a:xfrm>
            <a:off x="1804055" y="2771846"/>
            <a:ext cx="1677415" cy="1749452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01918144-D04B-D40F-FA20-A379916877DF}"/>
              </a:ext>
            </a:extLst>
          </p:cNvPr>
          <p:cNvPicPr>
            <a:picLocks noChangeAspect="1"/>
          </p:cNvPicPr>
          <p:nvPr/>
        </p:nvPicPr>
        <p:blipFill>
          <a:blip r:embed="rId19"/>
          <a:srcRect b="17275"/>
          <a:stretch/>
        </p:blipFill>
        <p:spPr>
          <a:xfrm>
            <a:off x="1827577" y="4647932"/>
            <a:ext cx="1646543" cy="1749452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BBCE61C4-07D0-A557-3543-17E85AC6F76E}"/>
              </a:ext>
            </a:extLst>
          </p:cNvPr>
          <p:cNvPicPr>
            <a:picLocks noChangeAspect="1"/>
          </p:cNvPicPr>
          <p:nvPr/>
        </p:nvPicPr>
        <p:blipFill>
          <a:blip r:embed="rId20"/>
          <a:srcRect b="17275"/>
          <a:stretch/>
        </p:blipFill>
        <p:spPr>
          <a:xfrm>
            <a:off x="1817399" y="922736"/>
            <a:ext cx="1677415" cy="1749452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5104F6BA-8FDB-EF70-2D8B-8710B0F5EE31}"/>
              </a:ext>
            </a:extLst>
          </p:cNvPr>
          <p:cNvSpPr txBox="1"/>
          <p:nvPr/>
        </p:nvSpPr>
        <p:spPr>
          <a:xfrm>
            <a:off x="1354601" y="823078"/>
            <a:ext cx="4717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A.</a:t>
            </a:r>
          </a:p>
        </p:txBody>
      </p: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19CC331B-88C9-F1B1-C410-9170BF1F4753}"/>
              </a:ext>
            </a:extLst>
          </p:cNvPr>
          <p:cNvCxnSpPr/>
          <p:nvPr/>
        </p:nvCxnSpPr>
        <p:spPr>
          <a:xfrm>
            <a:off x="2809507" y="2570927"/>
            <a:ext cx="0" cy="200919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42735FC4-3799-C29E-F11C-4EA7C2371F6E}"/>
              </a:ext>
            </a:extLst>
          </p:cNvPr>
          <p:cNvCxnSpPr/>
          <p:nvPr/>
        </p:nvCxnSpPr>
        <p:spPr>
          <a:xfrm>
            <a:off x="2809507" y="4430822"/>
            <a:ext cx="0" cy="200919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273D960F-A281-6F7A-63F8-2F186F6DF50E}"/>
              </a:ext>
            </a:extLst>
          </p:cNvPr>
          <p:cNvSpPr txBox="1"/>
          <p:nvPr/>
        </p:nvSpPr>
        <p:spPr>
          <a:xfrm>
            <a:off x="4662660" y="43834"/>
            <a:ext cx="4717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B.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F5966931-5D03-1F77-4A8B-9B23BC5E0F3B}"/>
              </a:ext>
            </a:extLst>
          </p:cNvPr>
          <p:cNvSpPr txBox="1"/>
          <p:nvPr/>
        </p:nvSpPr>
        <p:spPr>
          <a:xfrm>
            <a:off x="6332886" y="15027"/>
            <a:ext cx="4717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C.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FB1801F-91A0-1C86-1546-A74FE3392BE2}"/>
              </a:ext>
            </a:extLst>
          </p:cNvPr>
          <p:cNvSpPr txBox="1"/>
          <p:nvPr/>
        </p:nvSpPr>
        <p:spPr>
          <a:xfrm>
            <a:off x="4725754" y="1543123"/>
            <a:ext cx="4717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D.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4BC9CBA4-D86F-3F19-D3BC-CC2875B26206}"/>
              </a:ext>
            </a:extLst>
          </p:cNvPr>
          <p:cNvSpPr txBox="1"/>
          <p:nvPr/>
        </p:nvSpPr>
        <p:spPr>
          <a:xfrm>
            <a:off x="6335574" y="1529813"/>
            <a:ext cx="4717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E.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DAB682B1-DBA4-1DD2-D941-7C4783EEDB79}"/>
              </a:ext>
            </a:extLst>
          </p:cNvPr>
          <p:cNvSpPr txBox="1"/>
          <p:nvPr/>
        </p:nvSpPr>
        <p:spPr>
          <a:xfrm>
            <a:off x="8053388" y="55354"/>
            <a:ext cx="4717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.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644BCE6-ACB5-1BCB-673F-8ABAC50DABD4}"/>
              </a:ext>
            </a:extLst>
          </p:cNvPr>
          <p:cNvSpPr txBox="1"/>
          <p:nvPr/>
        </p:nvSpPr>
        <p:spPr>
          <a:xfrm>
            <a:off x="9723614" y="26547"/>
            <a:ext cx="4717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G.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FD008F6A-1848-3AD2-1F76-7CE46C979DE2}"/>
              </a:ext>
            </a:extLst>
          </p:cNvPr>
          <p:cNvSpPr txBox="1"/>
          <p:nvPr/>
        </p:nvSpPr>
        <p:spPr>
          <a:xfrm>
            <a:off x="8069009" y="1538575"/>
            <a:ext cx="4717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H.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42840C62-BCC8-7213-C9FB-47E73977C222}"/>
              </a:ext>
            </a:extLst>
          </p:cNvPr>
          <p:cNvSpPr txBox="1"/>
          <p:nvPr/>
        </p:nvSpPr>
        <p:spPr>
          <a:xfrm>
            <a:off x="9726302" y="1541333"/>
            <a:ext cx="4717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I.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0253165B-19F7-8F8C-7CC2-AE53F357D353}"/>
              </a:ext>
            </a:extLst>
          </p:cNvPr>
          <p:cNvSpPr txBox="1"/>
          <p:nvPr/>
        </p:nvSpPr>
        <p:spPr>
          <a:xfrm>
            <a:off x="4614946" y="3427878"/>
            <a:ext cx="4717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J.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DD62C8FE-3723-CC5B-6837-911B292C6210}"/>
              </a:ext>
            </a:extLst>
          </p:cNvPr>
          <p:cNvSpPr txBox="1"/>
          <p:nvPr/>
        </p:nvSpPr>
        <p:spPr>
          <a:xfrm>
            <a:off x="6285172" y="3399071"/>
            <a:ext cx="4717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K.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585B6ED2-CAFC-4BD6-F859-4564ADE53D29}"/>
              </a:ext>
            </a:extLst>
          </p:cNvPr>
          <p:cNvSpPr txBox="1"/>
          <p:nvPr/>
        </p:nvSpPr>
        <p:spPr>
          <a:xfrm>
            <a:off x="4630567" y="4911099"/>
            <a:ext cx="4717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L.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AD33C6F2-FE9E-ACFB-66D4-58134F7EC25E}"/>
              </a:ext>
            </a:extLst>
          </p:cNvPr>
          <p:cNvSpPr txBox="1"/>
          <p:nvPr/>
        </p:nvSpPr>
        <p:spPr>
          <a:xfrm>
            <a:off x="6335574" y="4916580"/>
            <a:ext cx="4717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M.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8F89E02E-B6C9-EF23-1CDC-9F7144400AA7}"/>
              </a:ext>
            </a:extLst>
          </p:cNvPr>
          <p:cNvSpPr txBox="1"/>
          <p:nvPr/>
        </p:nvSpPr>
        <p:spPr>
          <a:xfrm>
            <a:off x="8083804" y="3427866"/>
            <a:ext cx="4717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.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C39BF28F-4524-0031-603E-F14FB31068B5}"/>
              </a:ext>
            </a:extLst>
          </p:cNvPr>
          <p:cNvSpPr txBox="1"/>
          <p:nvPr/>
        </p:nvSpPr>
        <p:spPr>
          <a:xfrm>
            <a:off x="9687091" y="3416608"/>
            <a:ext cx="4717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O.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4A44BB65-BD47-0104-7D53-3B8F2F2EFBAF}"/>
              </a:ext>
            </a:extLst>
          </p:cNvPr>
          <p:cNvSpPr txBox="1"/>
          <p:nvPr/>
        </p:nvSpPr>
        <p:spPr>
          <a:xfrm>
            <a:off x="8099425" y="4911087"/>
            <a:ext cx="4717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P.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7920E96B-EB31-89DD-C6CD-32AD8A33F790}"/>
              </a:ext>
            </a:extLst>
          </p:cNvPr>
          <p:cNvSpPr txBox="1"/>
          <p:nvPr/>
        </p:nvSpPr>
        <p:spPr>
          <a:xfrm>
            <a:off x="9722408" y="4907634"/>
            <a:ext cx="4717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Q.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AD94853-D62F-0A4F-87FD-AE1898D5AF23}"/>
              </a:ext>
            </a:extLst>
          </p:cNvPr>
          <p:cNvSpPr txBox="1"/>
          <p:nvPr/>
        </p:nvSpPr>
        <p:spPr>
          <a:xfrm>
            <a:off x="35016" y="-15751"/>
            <a:ext cx="26654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ure 6</a:t>
            </a:r>
          </a:p>
        </p:txBody>
      </p:sp>
    </p:spTree>
    <p:extLst>
      <p:ext uri="{BB962C8B-B14F-4D97-AF65-F5344CB8AC3E}">
        <p14:creationId xmlns:p14="http://schemas.microsoft.com/office/powerpoint/2010/main" val="6171195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66</Words>
  <Application>Microsoft Office PowerPoint</Application>
  <PresentationFormat>Widescreen</PresentationFormat>
  <Paragraphs>3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urnett, Andrean L</dc:creator>
  <cp:lastModifiedBy>Burnett, Andrean L</cp:lastModifiedBy>
  <cp:revision>8</cp:revision>
  <dcterms:created xsi:type="dcterms:W3CDTF">2026-02-26T15:58:59Z</dcterms:created>
  <dcterms:modified xsi:type="dcterms:W3CDTF">2026-02-26T16:03:16Z</dcterms:modified>
</cp:coreProperties>
</file>